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6" r:id="rId2"/>
  </p:sldIdLst>
  <p:sldSz cx="9144000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4843"/>
    <p:restoredTop sz="94648"/>
  </p:normalViewPr>
  <p:slideViewPr>
    <p:cSldViewPr snapToGrid="0">
      <p:cViewPr varScale="1">
        <p:scale>
          <a:sx n="53" d="100"/>
          <a:sy n="53" d="100"/>
        </p:scale>
        <p:origin x="212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76CC82-E787-D040-9406-E6C8F2F29A69}" type="datetimeFigureOut">
              <a:rPr lang="en-US" smtClean="0"/>
              <a:t>6/4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9513" y="1143000"/>
            <a:ext cx="19589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E58DD9-2B26-3342-8F72-4A3BFDD476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7058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1" name="Google Shape;581;p1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82" name="Google Shape;582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449513" y="1143000"/>
            <a:ext cx="19589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41303499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356703"/>
            <a:ext cx="7772400" cy="501340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7563446"/>
            <a:ext cx="6858000" cy="3476717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891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2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766678"/>
            <a:ext cx="1971675" cy="1220351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766678"/>
            <a:ext cx="5800725" cy="1220351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269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12760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3590057"/>
            <a:ext cx="7886700" cy="5990088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9636813"/>
            <a:ext cx="7886700" cy="3150046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253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833390"/>
            <a:ext cx="3886200" cy="91368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833390"/>
            <a:ext cx="3886200" cy="91368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9848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66681"/>
            <a:ext cx="7886700" cy="27833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3530053"/>
            <a:ext cx="3868340" cy="17300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5260078"/>
            <a:ext cx="3868340" cy="77367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3530053"/>
            <a:ext cx="3887391" cy="17300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5260078"/>
            <a:ext cx="3887391" cy="77367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032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10340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93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960014"/>
            <a:ext cx="2949178" cy="33600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2073367"/>
            <a:ext cx="4629150" cy="1023348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320064"/>
            <a:ext cx="2949178" cy="80034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618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960014"/>
            <a:ext cx="2949178" cy="33600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2073367"/>
            <a:ext cx="4629150" cy="1023348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320064"/>
            <a:ext cx="2949178" cy="80034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644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766681"/>
            <a:ext cx="7886700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833390"/>
            <a:ext cx="7886700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3346867"/>
            <a:ext cx="20574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3346867"/>
            <a:ext cx="30861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3346867"/>
            <a:ext cx="20574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2267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EE80FC6-054E-F2FB-E7B4-09D8054F2B39}"/>
              </a:ext>
            </a:extLst>
          </p:cNvPr>
          <p:cNvGraphicFramePr>
            <a:graphicFrameLocks noGrp="1"/>
          </p:cNvGraphicFramePr>
          <p:nvPr/>
        </p:nvGraphicFramePr>
        <p:xfrm>
          <a:off x="1226268" y="2107990"/>
          <a:ext cx="6691463" cy="3316407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2623648">
                  <a:extLst>
                    <a:ext uri="{9D8B030D-6E8A-4147-A177-3AD203B41FA5}">
                      <a16:colId xmlns:a16="http://schemas.microsoft.com/office/drawing/2014/main" val="3752130334"/>
                    </a:ext>
                  </a:extLst>
                </a:gridCol>
                <a:gridCol w="1975088">
                  <a:extLst>
                    <a:ext uri="{9D8B030D-6E8A-4147-A177-3AD203B41FA5}">
                      <a16:colId xmlns:a16="http://schemas.microsoft.com/office/drawing/2014/main" val="581254728"/>
                    </a:ext>
                  </a:extLst>
                </a:gridCol>
                <a:gridCol w="2092727">
                  <a:extLst>
                    <a:ext uri="{9D8B030D-6E8A-4147-A177-3AD203B41FA5}">
                      <a16:colId xmlns:a16="http://schemas.microsoft.com/office/drawing/2014/main" val="3426889272"/>
                    </a:ext>
                  </a:extLst>
                </a:gridCol>
              </a:tblGrid>
              <a:tr h="273257"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Name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Company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Catalog Number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1600667841"/>
                  </a:ext>
                </a:extLst>
              </a:tr>
              <a:tr h="273257"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CD3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Invitrogen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MA1-10182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1665196022"/>
                  </a:ext>
                </a:extLst>
              </a:tr>
              <a:tr h="273257"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CD163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Abcam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ab182422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2672877035"/>
                  </a:ext>
                </a:extLst>
              </a:tr>
              <a:tr h="273257"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CD68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BioLegend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137001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252686348"/>
                  </a:ext>
                </a:extLst>
              </a:tr>
              <a:tr h="273257"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CXCL10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R&amp;D systems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AF-466-NA 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4010935192"/>
                  </a:ext>
                </a:extLst>
              </a:tr>
              <a:tr h="273257"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CXCR3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Sigma-Aldrich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SAB3501088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3174065352"/>
                  </a:ext>
                </a:extLst>
              </a:tr>
              <a:tr h="273257"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NK1.1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Invitrogen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14-5941-82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3165838692"/>
                  </a:ext>
                </a:extLst>
              </a:tr>
              <a:tr h="310580"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 dirty="0">
                          <a:effectLst/>
                        </a:rPr>
                        <a:t>Donkey anti-mouse AF488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Invitrogen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 dirty="0">
                          <a:effectLst/>
                        </a:rPr>
                        <a:t>A-21202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2848180825"/>
                  </a:ext>
                </a:extLst>
              </a:tr>
              <a:tr h="273257"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Goat anti-rat AF647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Invitrogen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A-21247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4284764497"/>
                  </a:ext>
                </a:extLst>
              </a:tr>
              <a:tr h="273257"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Goat anti-rabbit AF488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Invitrogen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A-11034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3216913502"/>
                  </a:ext>
                </a:extLst>
              </a:tr>
              <a:tr h="273257"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Goat anti-rat AF488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Invitrogen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A-11006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2893849429"/>
                  </a:ext>
                </a:extLst>
              </a:tr>
              <a:tr h="273257"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Anti-rabbit AF647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Invitrogen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indent="457200">
                        <a:lnSpc>
                          <a:spcPct val="150000"/>
                        </a:lnSpc>
                      </a:pPr>
                      <a:r>
                        <a:rPr lang="en-CA" sz="1100" dirty="0">
                          <a:effectLst/>
                        </a:rPr>
                        <a:t>A-21244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1926077111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596796E4-75B8-9758-3BC7-CEB5314999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6617" y="1483309"/>
            <a:ext cx="626755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indent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45720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Table 1. Immunofluorescence staining antibodies. </a:t>
            </a:r>
            <a:endParaRPr kumimoji="0" lang="en-US" altLang="en-US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53730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</TotalTime>
  <Words>57</Words>
  <Application>Microsoft Macintosh PowerPoint</Application>
  <PresentationFormat>Custom</PresentationFormat>
  <Paragraphs>3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smine Benslimane (CUSM)</dc:creator>
  <cp:lastModifiedBy>Yasmine Benslimane (CUSM)</cp:lastModifiedBy>
  <cp:revision>10</cp:revision>
  <dcterms:created xsi:type="dcterms:W3CDTF">2024-06-04T23:51:01Z</dcterms:created>
  <dcterms:modified xsi:type="dcterms:W3CDTF">2024-06-05T01:37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6a7d8d5d-78e2-4a62-9fcd-016eb5e4c57c_Enabled">
    <vt:lpwstr>true</vt:lpwstr>
  </property>
  <property fmtid="{D5CDD505-2E9C-101B-9397-08002B2CF9AE}" pid="3" name="MSIP_Label_6a7d8d5d-78e2-4a62-9fcd-016eb5e4c57c_SetDate">
    <vt:lpwstr>2024-06-04T23:52:34Z</vt:lpwstr>
  </property>
  <property fmtid="{D5CDD505-2E9C-101B-9397-08002B2CF9AE}" pid="4" name="MSIP_Label_6a7d8d5d-78e2-4a62-9fcd-016eb5e4c57c_Method">
    <vt:lpwstr>Standard</vt:lpwstr>
  </property>
  <property fmtid="{D5CDD505-2E9C-101B-9397-08002B2CF9AE}" pid="5" name="MSIP_Label_6a7d8d5d-78e2-4a62-9fcd-016eb5e4c57c_Name">
    <vt:lpwstr>Général</vt:lpwstr>
  </property>
  <property fmtid="{D5CDD505-2E9C-101B-9397-08002B2CF9AE}" pid="6" name="MSIP_Label_6a7d8d5d-78e2-4a62-9fcd-016eb5e4c57c_SiteId">
    <vt:lpwstr>06e1fe28-5f8b-4075-bf6c-ae24be1a7992</vt:lpwstr>
  </property>
  <property fmtid="{D5CDD505-2E9C-101B-9397-08002B2CF9AE}" pid="7" name="MSIP_Label_6a7d8d5d-78e2-4a62-9fcd-016eb5e4c57c_ActionId">
    <vt:lpwstr>7787e28e-b149-4962-94cc-d172c1dcb2b1</vt:lpwstr>
  </property>
  <property fmtid="{D5CDD505-2E9C-101B-9397-08002B2CF9AE}" pid="8" name="MSIP_Label_6a7d8d5d-78e2-4a62-9fcd-016eb5e4c57c_ContentBits">
    <vt:lpwstr>0</vt:lpwstr>
  </property>
</Properties>
</file>